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9588" cy="8004175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22">
          <p15:clr>
            <a:srgbClr val="A4A3A4"/>
          </p15:clr>
        </p15:guide>
        <p15:guide id="2" pos="216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29" autoAdjust="0"/>
  </p:normalViewPr>
  <p:slideViewPr>
    <p:cSldViewPr>
      <p:cViewPr varScale="1">
        <p:scale>
          <a:sx n="82" d="100"/>
          <a:sy n="82" d="100"/>
        </p:scale>
        <p:origin x="2488" y="44"/>
      </p:cViewPr>
      <p:guideLst>
        <p:guide orient="horz" pos="2522"/>
        <p:guide pos="21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DC305B-D344-444D-9568-68745DF13A2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804988" y="744538"/>
            <a:ext cx="3187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DDAA95-6386-469F-AB03-5CBBFCAF28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18423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469" y="2486485"/>
            <a:ext cx="5830650" cy="171570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938" y="4535699"/>
            <a:ext cx="4801712" cy="204551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3201" y="320539"/>
            <a:ext cx="1543407" cy="6829488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80" y="320539"/>
            <a:ext cx="4515895" cy="6829488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860" y="5143424"/>
            <a:ext cx="5830650" cy="158971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860" y="3392512"/>
            <a:ext cx="5830650" cy="17509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80" y="1867642"/>
            <a:ext cx="3029651" cy="528238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957" y="1867642"/>
            <a:ext cx="3029651" cy="528238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79" y="1791678"/>
            <a:ext cx="3030843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79" y="2538363"/>
            <a:ext cx="3030843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77" y="1791678"/>
            <a:ext cx="3032033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77" y="2538363"/>
            <a:ext cx="3032033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81" y="318686"/>
            <a:ext cx="2256757" cy="135626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908" y="318687"/>
            <a:ext cx="3834700" cy="683134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81" y="1674949"/>
            <a:ext cx="2256757" cy="54750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527" y="5602924"/>
            <a:ext cx="4115753" cy="66145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527" y="715190"/>
            <a:ext cx="4115753" cy="480250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527" y="6264379"/>
            <a:ext cx="4115753" cy="9393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80" y="320538"/>
            <a:ext cx="6173629" cy="13340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80" y="1867642"/>
            <a:ext cx="6173629" cy="52823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79" y="7418685"/>
            <a:ext cx="1600571" cy="4261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693" y="7418685"/>
            <a:ext cx="2172203" cy="4261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6038" y="7418685"/>
            <a:ext cx="1600571" cy="4261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 rot="18888705">
            <a:off x="1546996" y="123080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MOB2as-1 1x</a:t>
            </a:r>
          </a:p>
        </p:txBody>
      </p:sp>
      <p:sp>
        <p:nvSpPr>
          <p:cNvPr id="12" name="Textfeld 11"/>
          <p:cNvSpPr txBox="1"/>
          <p:nvPr/>
        </p:nvSpPr>
        <p:spPr>
          <a:xfrm rot="18888705">
            <a:off x="1812217" y="123080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MOB2as-1 3x</a:t>
            </a:r>
          </a:p>
        </p:txBody>
      </p:sp>
      <p:sp>
        <p:nvSpPr>
          <p:cNvPr id="13" name="Textfeld 12"/>
          <p:cNvSpPr txBox="1"/>
          <p:nvPr/>
        </p:nvSpPr>
        <p:spPr>
          <a:xfrm rot="18888705">
            <a:off x="2066910" y="123080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MOB2as-2 1x</a:t>
            </a:r>
          </a:p>
        </p:txBody>
      </p:sp>
      <p:sp>
        <p:nvSpPr>
          <p:cNvPr id="14" name="Textfeld 13"/>
          <p:cNvSpPr txBox="1"/>
          <p:nvPr/>
        </p:nvSpPr>
        <p:spPr>
          <a:xfrm rot="18888705">
            <a:off x="2335936" y="123080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MOB2as-2 3x</a:t>
            </a:r>
          </a:p>
        </p:txBody>
      </p:sp>
      <p:sp>
        <p:nvSpPr>
          <p:cNvPr id="15" name="Textfeld 14"/>
          <p:cNvSpPr txBox="1"/>
          <p:nvPr/>
        </p:nvSpPr>
        <p:spPr>
          <a:xfrm rot="18888705">
            <a:off x="2598940" y="123080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MOB2as-3 1x</a:t>
            </a:r>
          </a:p>
        </p:txBody>
      </p:sp>
      <p:sp>
        <p:nvSpPr>
          <p:cNvPr id="16" name="Textfeld 15"/>
          <p:cNvSpPr txBox="1"/>
          <p:nvPr/>
        </p:nvSpPr>
        <p:spPr>
          <a:xfrm rot="18888705">
            <a:off x="2865201" y="123080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MOB2as-3 3x</a:t>
            </a:r>
          </a:p>
        </p:txBody>
      </p:sp>
      <p:sp>
        <p:nvSpPr>
          <p:cNvPr id="17" name="Textfeld 16"/>
          <p:cNvSpPr txBox="1"/>
          <p:nvPr/>
        </p:nvSpPr>
        <p:spPr>
          <a:xfrm rot="18888705">
            <a:off x="3142683" y="131041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BK1as-1 1x</a:t>
            </a:r>
          </a:p>
        </p:txBody>
      </p:sp>
      <p:sp>
        <p:nvSpPr>
          <p:cNvPr id="18" name="Textfeld 17"/>
          <p:cNvSpPr txBox="1"/>
          <p:nvPr/>
        </p:nvSpPr>
        <p:spPr>
          <a:xfrm rot="18888705">
            <a:off x="3401629" y="131041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BK1as-1 3x</a:t>
            </a:r>
          </a:p>
        </p:txBody>
      </p:sp>
      <p:sp>
        <p:nvSpPr>
          <p:cNvPr id="19" name="Textfeld 18"/>
          <p:cNvSpPr txBox="1"/>
          <p:nvPr/>
        </p:nvSpPr>
        <p:spPr>
          <a:xfrm rot="18888705">
            <a:off x="3660575" y="131041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BK1as-2 1x</a:t>
            </a:r>
          </a:p>
        </p:txBody>
      </p:sp>
      <p:sp>
        <p:nvSpPr>
          <p:cNvPr id="20" name="Textfeld 19"/>
          <p:cNvSpPr txBox="1"/>
          <p:nvPr/>
        </p:nvSpPr>
        <p:spPr>
          <a:xfrm rot="18888705">
            <a:off x="3919521" y="131041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BK1as-2 3x</a:t>
            </a:r>
          </a:p>
        </p:txBody>
      </p:sp>
      <p:sp>
        <p:nvSpPr>
          <p:cNvPr id="21" name="Textfeld 20"/>
          <p:cNvSpPr txBox="1"/>
          <p:nvPr/>
        </p:nvSpPr>
        <p:spPr>
          <a:xfrm rot="18888705">
            <a:off x="4452040" y="131041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BK1as-3 3x</a:t>
            </a:r>
          </a:p>
        </p:txBody>
      </p:sp>
      <p:sp>
        <p:nvSpPr>
          <p:cNvPr id="22" name="Textfeld 21"/>
          <p:cNvSpPr txBox="1"/>
          <p:nvPr/>
        </p:nvSpPr>
        <p:spPr>
          <a:xfrm rot="18888705">
            <a:off x="4193097" y="131041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BK1as-3 1x</a:t>
            </a:r>
          </a:p>
        </p:txBody>
      </p:sp>
      <p:pic>
        <p:nvPicPr>
          <p:cNvPr id="4" name="Picture 2" descr="D:\Johannes\Agarosegelbilder\dez16\IM001449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6" t="27703" r="78131" b="59583"/>
          <a:stretch/>
        </p:blipFill>
        <p:spPr bwMode="auto">
          <a:xfrm>
            <a:off x="4829286" y="502061"/>
            <a:ext cx="1104577" cy="5231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D:\Johannes\Agarosegelbilder\dez16\IM001448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50" t="22143" r="10276" b="65178"/>
          <a:stretch/>
        </p:blipFill>
        <p:spPr bwMode="auto">
          <a:xfrm>
            <a:off x="11713" y="502060"/>
            <a:ext cx="4782710" cy="5217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feld 5"/>
          <p:cNvSpPr txBox="1"/>
          <p:nvPr/>
        </p:nvSpPr>
        <p:spPr>
          <a:xfrm rot="18888705">
            <a:off x="256170" y="249311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8888705">
            <a:off x="539669" y="241350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 1x</a:t>
            </a:r>
          </a:p>
        </p:txBody>
      </p:sp>
      <p:sp>
        <p:nvSpPr>
          <p:cNvPr id="8" name="Textfeld 7"/>
          <p:cNvSpPr txBox="1"/>
          <p:nvPr/>
        </p:nvSpPr>
        <p:spPr>
          <a:xfrm rot="18888705">
            <a:off x="1059073" y="206666"/>
            <a:ext cx="5790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vir-88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x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 rot="18888705">
            <a:off x="807959" y="241350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 3x</a:t>
            </a:r>
          </a:p>
        </p:txBody>
      </p:sp>
      <p:sp>
        <p:nvSpPr>
          <p:cNvPr id="11" name="Textfeld 10"/>
          <p:cNvSpPr txBox="1"/>
          <p:nvPr/>
        </p:nvSpPr>
        <p:spPr>
          <a:xfrm rot="18888705">
            <a:off x="1322077" y="206666"/>
            <a:ext cx="5790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vir-88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x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 rot="18888705">
            <a:off x="5331600" y="248743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V 3x</a:t>
            </a:r>
          </a:p>
        </p:txBody>
      </p:sp>
      <p:sp>
        <p:nvSpPr>
          <p:cNvPr id="24" name="Textfeld 23"/>
          <p:cNvSpPr txBox="1"/>
          <p:nvPr/>
        </p:nvSpPr>
        <p:spPr>
          <a:xfrm rot="18888705">
            <a:off x="5053774" y="248743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V 1x</a:t>
            </a:r>
          </a:p>
        </p:txBody>
      </p:sp>
      <p:sp>
        <p:nvSpPr>
          <p:cNvPr id="25" name="Textfeld 24"/>
          <p:cNvSpPr txBox="1"/>
          <p:nvPr/>
        </p:nvSpPr>
        <p:spPr>
          <a:xfrm rot="18888705">
            <a:off x="5611932" y="278310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grpSp>
        <p:nvGrpSpPr>
          <p:cNvPr id="75" name="Gruppieren 74"/>
          <p:cNvGrpSpPr/>
          <p:nvPr/>
        </p:nvGrpSpPr>
        <p:grpSpPr>
          <a:xfrm>
            <a:off x="13038" y="990289"/>
            <a:ext cx="4302585" cy="1246526"/>
            <a:chOff x="13038" y="1123110"/>
            <a:chExt cx="4302585" cy="1246526"/>
          </a:xfrm>
        </p:grpSpPr>
        <p:pic>
          <p:nvPicPr>
            <p:cNvPr id="26" name="Picture 2" descr="D:\Johannes\Agarosegelbilder\dez16\IM001451.JPG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5" t="42333" r="9868" b="42333"/>
            <a:stretch/>
          </p:blipFill>
          <p:spPr bwMode="auto">
            <a:xfrm>
              <a:off x="13038" y="1811636"/>
              <a:ext cx="4302585" cy="5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4" name="Textfeld 33"/>
            <p:cNvSpPr txBox="1"/>
            <p:nvPr/>
          </p:nvSpPr>
          <p:spPr>
            <a:xfrm rot="18888705">
              <a:off x="249146" y="1548943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gDN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feld 34"/>
            <p:cNvSpPr txBox="1"/>
            <p:nvPr/>
          </p:nvSpPr>
          <p:spPr>
            <a:xfrm rot="18888705">
              <a:off x="532645" y="1540982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T 1x</a:t>
              </a:r>
            </a:p>
          </p:txBody>
        </p:sp>
        <p:sp>
          <p:nvSpPr>
            <p:cNvPr id="36" name="Textfeld 35"/>
            <p:cNvSpPr txBox="1"/>
            <p:nvPr/>
          </p:nvSpPr>
          <p:spPr>
            <a:xfrm rot="18888705">
              <a:off x="1052049" y="1506298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vir-88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x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 rot="18888705">
              <a:off x="1552328" y="1422712"/>
              <a:ext cx="8146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OB2as-1 1x</a:t>
              </a:r>
            </a:p>
          </p:txBody>
        </p:sp>
        <p:sp>
          <p:nvSpPr>
            <p:cNvPr id="38" name="Textfeld 37"/>
            <p:cNvSpPr txBox="1"/>
            <p:nvPr/>
          </p:nvSpPr>
          <p:spPr>
            <a:xfrm rot="18888705">
              <a:off x="800935" y="1540982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T 3x</a:t>
              </a:r>
            </a:p>
          </p:txBody>
        </p:sp>
        <p:sp>
          <p:nvSpPr>
            <p:cNvPr id="39" name="Textfeld 38"/>
            <p:cNvSpPr txBox="1"/>
            <p:nvPr/>
          </p:nvSpPr>
          <p:spPr>
            <a:xfrm rot="18888705">
              <a:off x="1315053" y="1506298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vir-88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 rot="18888705">
              <a:off x="1817549" y="1422712"/>
              <a:ext cx="8146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OB2as-1 3x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 rot="18888705">
              <a:off x="2072242" y="1422712"/>
              <a:ext cx="8146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OB2as-2 1x</a:t>
              </a:r>
            </a:p>
          </p:txBody>
        </p:sp>
        <p:sp>
          <p:nvSpPr>
            <p:cNvPr id="42" name="Textfeld 41"/>
            <p:cNvSpPr txBox="1"/>
            <p:nvPr/>
          </p:nvSpPr>
          <p:spPr>
            <a:xfrm rot="18888705">
              <a:off x="2341268" y="1422712"/>
              <a:ext cx="8146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OB2as-2 3x</a:t>
              </a:r>
            </a:p>
          </p:txBody>
        </p:sp>
        <p:sp>
          <p:nvSpPr>
            <p:cNvPr id="43" name="Textfeld 42"/>
            <p:cNvSpPr txBox="1"/>
            <p:nvPr/>
          </p:nvSpPr>
          <p:spPr>
            <a:xfrm rot="18888705">
              <a:off x="2604272" y="1422712"/>
              <a:ext cx="8146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OB2as-3 1x</a:t>
              </a:r>
            </a:p>
          </p:txBody>
        </p:sp>
        <p:sp>
          <p:nvSpPr>
            <p:cNvPr id="44" name="Textfeld 43"/>
            <p:cNvSpPr txBox="1"/>
            <p:nvPr/>
          </p:nvSpPr>
          <p:spPr>
            <a:xfrm rot="18888705">
              <a:off x="2870533" y="1422712"/>
              <a:ext cx="8146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OB2as-3 3x</a:t>
              </a:r>
            </a:p>
          </p:txBody>
        </p:sp>
        <p:sp>
          <p:nvSpPr>
            <p:cNvPr id="51" name="Textfeld 50"/>
            <p:cNvSpPr txBox="1"/>
            <p:nvPr/>
          </p:nvSpPr>
          <p:spPr>
            <a:xfrm rot="18888705">
              <a:off x="3475348" y="1548375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V 3x</a:t>
              </a:r>
            </a:p>
          </p:txBody>
        </p:sp>
        <p:sp>
          <p:nvSpPr>
            <p:cNvPr id="52" name="Textfeld 51"/>
            <p:cNvSpPr txBox="1"/>
            <p:nvPr/>
          </p:nvSpPr>
          <p:spPr>
            <a:xfrm rot="18888705">
              <a:off x="3197522" y="1548375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V 1x</a:t>
              </a:r>
            </a:p>
          </p:txBody>
        </p:sp>
        <p:sp>
          <p:nvSpPr>
            <p:cNvPr id="53" name="Textfeld 52"/>
            <p:cNvSpPr txBox="1"/>
            <p:nvPr/>
          </p:nvSpPr>
          <p:spPr>
            <a:xfrm rot="18888705">
              <a:off x="3755680" y="1577942"/>
              <a:ext cx="3770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</p:grpSp>
      <p:grpSp>
        <p:nvGrpSpPr>
          <p:cNvPr id="76" name="Gruppieren 75"/>
          <p:cNvGrpSpPr/>
          <p:nvPr/>
        </p:nvGrpSpPr>
        <p:grpSpPr>
          <a:xfrm>
            <a:off x="11712" y="2201887"/>
            <a:ext cx="4303911" cy="1222679"/>
            <a:chOff x="11712" y="2491376"/>
            <a:chExt cx="4303911" cy="1222679"/>
          </a:xfrm>
        </p:grpSpPr>
        <p:pic>
          <p:nvPicPr>
            <p:cNvPr id="28" name="Picture 4" descr="D:\Johannes\Agarosegelbilder\dez16\IM001455.JPG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8" t="32052" r="18102" b="53891"/>
            <a:stretch/>
          </p:blipFill>
          <p:spPr bwMode="auto">
            <a:xfrm>
              <a:off x="11712" y="3156055"/>
              <a:ext cx="4303911" cy="5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4" name="Textfeld 53"/>
            <p:cNvSpPr txBox="1"/>
            <p:nvPr/>
          </p:nvSpPr>
          <p:spPr>
            <a:xfrm rot="18888705">
              <a:off x="249146" y="2898027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gDN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feld 54"/>
            <p:cNvSpPr txBox="1"/>
            <p:nvPr/>
          </p:nvSpPr>
          <p:spPr>
            <a:xfrm rot="18888705">
              <a:off x="532645" y="2890066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T 1x</a:t>
              </a:r>
            </a:p>
          </p:txBody>
        </p:sp>
        <p:sp>
          <p:nvSpPr>
            <p:cNvPr id="56" name="Textfeld 55"/>
            <p:cNvSpPr txBox="1"/>
            <p:nvPr/>
          </p:nvSpPr>
          <p:spPr>
            <a:xfrm rot="18888705">
              <a:off x="1021159" y="2855382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vir-88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x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feld 57"/>
            <p:cNvSpPr txBox="1"/>
            <p:nvPr/>
          </p:nvSpPr>
          <p:spPr>
            <a:xfrm rot="18888705">
              <a:off x="800935" y="2890066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T 3x</a:t>
              </a:r>
            </a:p>
          </p:txBody>
        </p:sp>
        <p:sp>
          <p:nvSpPr>
            <p:cNvPr id="59" name="Textfeld 58"/>
            <p:cNvSpPr txBox="1"/>
            <p:nvPr/>
          </p:nvSpPr>
          <p:spPr>
            <a:xfrm rot="18888705">
              <a:off x="1284163" y="2855382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vir-88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x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feld 64"/>
            <p:cNvSpPr txBox="1"/>
            <p:nvPr/>
          </p:nvSpPr>
          <p:spPr>
            <a:xfrm rot="18888705">
              <a:off x="1510892" y="2779757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CBK1as-1 1x</a:t>
              </a:r>
            </a:p>
          </p:txBody>
        </p:sp>
        <p:sp>
          <p:nvSpPr>
            <p:cNvPr id="66" name="Textfeld 65"/>
            <p:cNvSpPr txBox="1"/>
            <p:nvPr/>
          </p:nvSpPr>
          <p:spPr>
            <a:xfrm rot="18888705">
              <a:off x="1782194" y="2779757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CBK1as-1 3x</a:t>
              </a:r>
            </a:p>
          </p:txBody>
        </p:sp>
        <p:sp>
          <p:nvSpPr>
            <p:cNvPr id="67" name="Textfeld 66"/>
            <p:cNvSpPr txBox="1"/>
            <p:nvPr/>
          </p:nvSpPr>
          <p:spPr>
            <a:xfrm rot="18888705">
              <a:off x="2041140" y="2779757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CBK1as-2 1x</a:t>
              </a:r>
            </a:p>
          </p:txBody>
        </p:sp>
        <p:sp>
          <p:nvSpPr>
            <p:cNvPr id="68" name="Textfeld 67"/>
            <p:cNvSpPr txBox="1"/>
            <p:nvPr/>
          </p:nvSpPr>
          <p:spPr>
            <a:xfrm rot="18888705">
              <a:off x="2312442" y="2779757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CBK1as-2 3x</a:t>
              </a:r>
            </a:p>
          </p:txBody>
        </p:sp>
        <p:sp>
          <p:nvSpPr>
            <p:cNvPr id="69" name="Textfeld 68"/>
            <p:cNvSpPr txBox="1"/>
            <p:nvPr/>
          </p:nvSpPr>
          <p:spPr>
            <a:xfrm rot="18888705">
              <a:off x="2844961" y="2779757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CBK1as-3 3x</a:t>
              </a:r>
            </a:p>
          </p:txBody>
        </p:sp>
        <p:sp>
          <p:nvSpPr>
            <p:cNvPr id="70" name="Textfeld 69"/>
            <p:cNvSpPr txBox="1"/>
            <p:nvPr/>
          </p:nvSpPr>
          <p:spPr>
            <a:xfrm rot="18888705">
              <a:off x="2586018" y="2779757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CBK1as-3 1x</a:t>
              </a:r>
            </a:p>
          </p:txBody>
        </p:sp>
        <p:sp>
          <p:nvSpPr>
            <p:cNvPr id="71" name="Textfeld 70"/>
            <p:cNvSpPr txBox="1"/>
            <p:nvPr/>
          </p:nvSpPr>
          <p:spPr>
            <a:xfrm rot="18888705">
              <a:off x="3434230" y="2897459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V 3x</a:t>
              </a:r>
            </a:p>
          </p:txBody>
        </p:sp>
        <p:sp>
          <p:nvSpPr>
            <p:cNvPr id="72" name="Textfeld 71"/>
            <p:cNvSpPr txBox="1"/>
            <p:nvPr/>
          </p:nvSpPr>
          <p:spPr>
            <a:xfrm rot="18888705">
              <a:off x="3156404" y="2897459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V 1x</a:t>
              </a:r>
            </a:p>
          </p:txBody>
        </p:sp>
        <p:sp>
          <p:nvSpPr>
            <p:cNvPr id="73" name="Textfeld 72"/>
            <p:cNvSpPr txBox="1"/>
            <p:nvPr/>
          </p:nvSpPr>
          <p:spPr>
            <a:xfrm rot="18888705">
              <a:off x="3714562" y="2927026"/>
              <a:ext cx="3770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</p:grpSp>
      <p:sp>
        <p:nvSpPr>
          <p:cNvPr id="77" name="Textfeld 76"/>
          <p:cNvSpPr txBox="1"/>
          <p:nvPr/>
        </p:nvSpPr>
        <p:spPr>
          <a:xfrm>
            <a:off x="5871888" y="639806"/>
            <a:ext cx="1452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hTUBULIN-</a:t>
            </a:r>
            <a:r>
              <a:rPr lang="el-G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4256822" y="1834704"/>
            <a:ext cx="1452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hMOB2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4256822" y="3022455"/>
            <a:ext cx="1452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hCBK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73266" y="3781995"/>
            <a:ext cx="6668895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4: Figure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3.pptx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lencing constructs directed against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hMOB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hCbk1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d not lead to significant reduction of the respective transcripts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mi-quantitative RT-PCRs for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hMOB2, ChCBK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ChTUBULIN-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 samples from conidia. 1 µl (1x) and 3 µl (3x) of cDNA of the wild-type strain (CY5535)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vir-8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3 transformants each of wild-type transformed with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hMOB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OB2as-1 to -3) or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hCBK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OB2as-1 to -3) antisense silencing constructs (pCK5250 and pCK5249, respectively) were used as template for PCR. Genomic wild-type DNA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no template (H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) and cDNA from wild-type transformed with the empty vector were used as controls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061923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1</Words>
  <Application>Microsoft Office PowerPoint</Application>
  <PresentationFormat>Benutzerdefiniert</PresentationFormat>
  <Paragraphs>5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-Desig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annes</dc:creator>
  <cp:lastModifiedBy>johannes.schmidpeter@altmuehlnet.de</cp:lastModifiedBy>
  <cp:revision>105</cp:revision>
  <cp:lastPrinted>2016-11-29T09:04:05Z</cp:lastPrinted>
  <dcterms:created xsi:type="dcterms:W3CDTF">2016-01-13T09:32:30Z</dcterms:created>
  <dcterms:modified xsi:type="dcterms:W3CDTF">2017-01-10T10:09:02Z</dcterms:modified>
</cp:coreProperties>
</file>